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93" d="100"/>
          <a:sy n="93" d="100"/>
        </p:scale>
        <p:origin x="3408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F028F3-B898-B94C-9E5A-2424B8061AE8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2D9568-BE70-1440-A676-08A4D1FD5B2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9319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E2D9568-BE70-1440-A676-08A4D1FD5B2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239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115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362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682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850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588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37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064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0898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795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476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118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25070-7311-6B46-85CC-38A55A7F8710}" type="datetimeFigureOut">
              <a:rPr kumimoji="1" lang="ja-JP" altLang="en-US" smtClean="0"/>
              <a:t>2023/8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558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429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3429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buFont typeface="Arial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1" latinLnBrk="0" hangingPunct="1">
        <a:spcBef>
          <a:spcPct val="20000"/>
        </a:spcBef>
        <a:buFont typeface="Arial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1" latinLnBrk="0" hangingPunct="1">
        <a:spcBef>
          <a:spcPct val="20000"/>
        </a:spcBef>
        <a:buFont typeface="Arial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76535F5E-DD26-8749-B451-79C543095F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4487" y="948683"/>
            <a:ext cx="2497783" cy="199239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F1F7EA40-362F-0442-A065-96DF88F1C2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35398" y="2784313"/>
            <a:ext cx="2495037" cy="2001889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9D979D82-FFC1-F948-B62A-0D4D03EB06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1543" y="4682837"/>
            <a:ext cx="2495037" cy="1978656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8984B70-4DC7-6941-8363-CF6898B216FC}"/>
              </a:ext>
            </a:extLst>
          </p:cNvPr>
          <p:cNvSpPr txBox="1"/>
          <p:nvPr/>
        </p:nvSpPr>
        <p:spPr>
          <a:xfrm>
            <a:off x="95945" y="1038116"/>
            <a:ext cx="2000605" cy="6924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ure FEV1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time-course changes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FEV1 in Drug-treated patients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ePAP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less severe PH</a:t>
            </a:r>
            <a:r>
              <a:rPr lang="ja-JP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29E6A85-4422-8F49-8CF0-86064EFD187C}"/>
              </a:ext>
            </a:extLst>
          </p:cNvPr>
          <p:cNvSpPr txBox="1"/>
          <p:nvPr/>
        </p:nvSpPr>
        <p:spPr>
          <a:xfrm>
            <a:off x="144996" y="2672663"/>
            <a:ext cx="1858201" cy="69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ure FEV1%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time-course changes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FEV1% in Drug-treated patients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ePAP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less severe PH</a:t>
            </a:r>
            <a:r>
              <a:rPr lang="ja-JP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0CA45F9-85B5-B947-80D4-346A3B1C68D3}"/>
              </a:ext>
            </a:extLst>
          </p:cNvPr>
          <p:cNvSpPr txBox="1"/>
          <p:nvPr/>
        </p:nvSpPr>
        <p:spPr>
          <a:xfrm>
            <a:off x="148419" y="4572000"/>
            <a:ext cx="1858201" cy="6924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 Figure %FEV1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sessment of time-course changes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FEV1% in Drug-treated patients </a:t>
            </a:r>
          </a:p>
          <a:p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ePAP</a:t>
            </a:r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less severe PH</a:t>
            </a:r>
            <a:r>
              <a:rPr lang="ja-JP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FAF55F5-4BA2-7F47-86BB-4A0B8AF78916}"/>
              </a:ext>
            </a:extLst>
          </p:cNvPr>
          <p:cNvSpPr txBox="1"/>
          <p:nvPr/>
        </p:nvSpPr>
        <p:spPr>
          <a:xfrm rot="16200000">
            <a:off x="1441184" y="1868026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V1(L)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385EA64-0565-AC49-985E-216B6BA5E500}"/>
              </a:ext>
            </a:extLst>
          </p:cNvPr>
          <p:cNvSpPr txBox="1"/>
          <p:nvPr/>
        </p:nvSpPr>
        <p:spPr>
          <a:xfrm rot="16200000">
            <a:off x="1360231" y="3608775"/>
            <a:ext cx="910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V1%(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3E5CE42-6847-B143-978D-52CEA632A568}"/>
              </a:ext>
            </a:extLst>
          </p:cNvPr>
          <p:cNvSpPr txBox="1"/>
          <p:nvPr/>
        </p:nvSpPr>
        <p:spPr>
          <a:xfrm rot="16200000">
            <a:off x="1360231" y="5495309"/>
            <a:ext cx="9108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FEV1(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%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3257050-C232-F84A-874D-CEB0258E0B99}"/>
              </a:ext>
            </a:extLst>
          </p:cNvPr>
          <p:cNvSpPr txBox="1"/>
          <p:nvPr/>
        </p:nvSpPr>
        <p:spPr>
          <a:xfrm>
            <a:off x="2096550" y="6568883"/>
            <a:ext cx="26212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 line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12           month24</a:t>
            </a: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nth6            month18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646E2D1-2B28-9045-A60F-7A33772123BD}"/>
              </a:ext>
            </a:extLst>
          </p:cNvPr>
          <p:cNvSpPr txBox="1"/>
          <p:nvPr/>
        </p:nvSpPr>
        <p:spPr>
          <a:xfrm>
            <a:off x="35825" y="15943"/>
            <a:ext cx="682217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Supplementary Figure 4: Assessment of time-course changes in (</a:t>
            </a:r>
            <a:r>
              <a:rPr lang="en-US" altLang="ja-JP" sz="1800" b="1" kern="100" dirty="0">
                <a:effectLst/>
                <a:ea typeface="ＭＳ 明朝" panose="02020609040205080304" pitchFamily="17" charset="-128"/>
              </a:rPr>
              <a:t>airflow obstruction indices of pulmonary function parameters</a:t>
            </a:r>
            <a:r>
              <a:rPr lang="en-US" altLang="ja-JP" b="1" dirty="0"/>
              <a:t>) in drug-treated patients with </a:t>
            </a:r>
            <a:r>
              <a:rPr lang="en-US" altLang="ja-JP" b="1" dirty="0" err="1"/>
              <a:t>eePAP</a:t>
            </a:r>
            <a:r>
              <a:rPr lang="en-US" altLang="ja-JP" b="1" dirty="0"/>
              <a:t> or less severe PH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5D6990D-E6C7-5A7A-67EA-F5A0E97B4175}"/>
              </a:ext>
            </a:extLst>
          </p:cNvPr>
          <p:cNvSpPr txBox="1"/>
          <p:nvPr/>
        </p:nvSpPr>
        <p:spPr>
          <a:xfrm>
            <a:off x="547254" y="7126430"/>
            <a:ext cx="576349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800" kern="100" dirty="0">
                <a:effectLst/>
                <a:latin typeface="Times New Roman" panose="02020603050405020304" pitchFamily="18" charset="0"/>
                <a:ea typeface="ＭＳ 明朝" panose="02020609040205080304" pitchFamily="49" charset="-128"/>
              </a:rPr>
              <a:t>Significant, but slight decrease was noted in FEV1 (forced expiratory volume in one second) and FEV1% (%forced expiratory volume in one second / forced vital capacity) at months 12, 18, 24, while No significant difference was noted in %FEV1 for 2 years.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50153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0</TotalTime>
  <Words>155</Words>
  <Application>Microsoft Macintosh PowerPoint</Application>
  <PresentationFormat>画面に合わせる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>N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中 庸介</dc:creator>
  <cp:lastModifiedBy>田中 庸介</cp:lastModifiedBy>
  <cp:revision>13</cp:revision>
  <dcterms:created xsi:type="dcterms:W3CDTF">2017-05-25T11:10:04Z</dcterms:created>
  <dcterms:modified xsi:type="dcterms:W3CDTF">2023-08-14T06:48:50Z</dcterms:modified>
</cp:coreProperties>
</file>